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67B98C-E3F2-46A5-97DB-2A502A724C8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4C3B24-F444-46A1-8420-51F496866D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9FC2E1-45BD-42EC-89BD-61E9C7612B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87F173-4840-4FB0-ABAA-3C22149BC3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0E24082-6A4D-4E53-8AFA-17E7BA0EA38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B44645C-2104-43DD-ABB7-2DEEF9BA26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8D934B9-A634-43EE-ABBB-4E2EC4BE82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756341E-CEA0-406B-A31C-CF0F3CBFEF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BFEFE8C-A0E7-4D0E-83DF-79FC4D2A8A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6E4BB7E-6FC4-4DCF-B5B9-BC534DF944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1E5AB30-9E47-409A-A2A8-9B6FE12B25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0F82E8-4BE6-4364-A235-1FE72A71A8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807DE7D-4A58-4E8E-A624-29575E4FED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FAC4ED6-AB07-4C0B-815D-D8503174DD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EFF8E57-49FA-4E04-80AF-A204C01017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2041191-E335-4BB2-A5B8-8A219D2F2A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DD67713-7080-454F-B52B-17584DE67B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EC37F0-D894-40D6-BEC3-B33874A4F9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902F6D-DDAC-4DDD-9F1A-4E55C991F8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324C77-7B35-4977-BB1D-39F0A8E3FB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0F5488-D66D-4D8B-A0B4-4A636DB6D9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46A5FA-FC71-40FE-904A-E8EEB40B74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3C2CD1-E568-4B45-B972-9A282C4B96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328FE-FE83-4F72-90DD-D4558A055F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BF5F1F-CD38-4E71-9C4D-6AF7D4903B36}" type="slidenum"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D75F45-5134-4429-91B6-CB51E330EC27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矩形 5"/>
          <p:cNvSpPr/>
          <p:nvPr/>
        </p:nvSpPr>
        <p:spPr>
          <a:xfrm>
            <a:off x="1616040" y="466560"/>
            <a:ext cx="2449440" cy="405000"/>
          </a:xfrm>
          <a:prstGeom prst="rect">
            <a:avLst/>
          </a:prstGeom>
          <a:solidFill>
            <a:srgbClr val="ffffff"/>
          </a:solidFill>
          <a:ln w="25560">
            <a:solidFill>
              <a:srgbClr val="bcbcb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0000"/>
              </a:lnSpc>
              <a:spcAft>
                <a:spcPts val="788"/>
              </a:spcAft>
              <a:tabLst>
                <a:tab algn="l" pos="0"/>
                <a:tab algn="l" pos="1111320"/>
                <a:tab algn="l" pos="2222640"/>
                <a:tab algn="l" pos="3333600"/>
                <a:tab algn="l" pos="4444920"/>
                <a:tab algn="l" pos="5556240"/>
                <a:tab algn="l" pos="6667560"/>
                <a:tab algn="l" pos="7778880"/>
                <a:tab algn="l" pos="8889840"/>
                <a:tab algn="l" pos="100011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ontacted (n=386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矩形 6"/>
          <p:cNvSpPr/>
          <p:nvPr/>
        </p:nvSpPr>
        <p:spPr>
          <a:xfrm>
            <a:off x="271440" y="7037280"/>
            <a:ext cx="5461200" cy="1044720"/>
          </a:xfrm>
          <a:prstGeom prst="rect">
            <a:avLst/>
          </a:prstGeom>
          <a:solidFill>
            <a:srgbClr val="ffffff"/>
          </a:solidFill>
          <a:ln w="25560">
            <a:solidFill>
              <a:srgbClr val="bcbcb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0000"/>
              </a:lnSpc>
              <a:spcAft>
                <a:spcPts val="788"/>
              </a:spcAft>
              <a:tabLst>
                <a:tab algn="l" pos="0"/>
                <a:tab algn="l" pos="1111320"/>
                <a:tab algn="l" pos="2222640"/>
                <a:tab algn="l" pos="3333600"/>
                <a:tab algn="l" pos="4444920"/>
                <a:tab algn="l" pos="5556240"/>
                <a:tab algn="l" pos="6667560"/>
                <a:tab algn="l" pos="7778880"/>
                <a:tab algn="l" pos="8889840"/>
                <a:tab algn="l" pos="100011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nthropological measurements, blood collection, blood pressure record (n=64-7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矩形 7"/>
          <p:cNvSpPr/>
          <p:nvPr/>
        </p:nvSpPr>
        <p:spPr>
          <a:xfrm>
            <a:off x="2840040" y="1830240"/>
            <a:ext cx="3962520" cy="1106640"/>
          </a:xfrm>
          <a:prstGeom prst="rect">
            <a:avLst/>
          </a:prstGeom>
          <a:solidFill>
            <a:srgbClr val="ffffff"/>
          </a:solidFill>
          <a:ln w="25560">
            <a:solidFill>
              <a:srgbClr val="bcbcb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90000"/>
              </a:lnSpc>
              <a:spcAft>
                <a:spcPts val="788"/>
              </a:spcAft>
              <a:tabLst>
                <a:tab algn="l" pos="0"/>
                <a:tab algn="l" pos="1111320"/>
                <a:tab algn="l" pos="2222640"/>
                <a:tab algn="l" pos="3333600"/>
                <a:tab algn="l" pos="4444920"/>
                <a:tab algn="l" pos="5556240"/>
                <a:tab algn="l" pos="6667560"/>
                <a:tab algn="l" pos="7778880"/>
                <a:tab algn="l" pos="8889840"/>
                <a:tab algn="l" pos="100011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Excluded (n=23)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1111320"/>
                <a:tab algn="l" pos="2222640"/>
                <a:tab algn="l" pos="3333600"/>
                <a:tab algn="l" pos="4444920"/>
                <a:tab algn="l" pos="5556240"/>
                <a:tab algn="l" pos="6667560"/>
                <a:tab algn="l" pos="7778880"/>
                <a:tab algn="l" pos="8889840"/>
                <a:tab algn="l" pos="100011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- did not meet inclusion criteria (n=19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1111320"/>
                <a:tab algn="l" pos="2222640"/>
                <a:tab algn="l" pos="3333600"/>
                <a:tab algn="l" pos="4444920"/>
                <a:tab algn="l" pos="5556240"/>
                <a:tab algn="l" pos="6667560"/>
                <a:tab algn="l" pos="7778880"/>
                <a:tab algn="l" pos="8889840"/>
                <a:tab algn="l" pos="100011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- withdrew consent (n=2)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1111320"/>
                <a:tab algn="l" pos="2222640"/>
                <a:tab algn="l" pos="3333600"/>
                <a:tab algn="l" pos="4444920"/>
                <a:tab algn="l" pos="5556240"/>
                <a:tab algn="l" pos="6667560"/>
                <a:tab algn="l" pos="7778880"/>
                <a:tab algn="l" pos="8889840"/>
                <a:tab algn="l" pos="100011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- lost contact (n=2)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矩形 8"/>
          <p:cNvSpPr/>
          <p:nvPr/>
        </p:nvSpPr>
        <p:spPr>
          <a:xfrm>
            <a:off x="932040" y="1219320"/>
            <a:ext cx="3889080" cy="441360"/>
          </a:xfrm>
          <a:prstGeom prst="rect">
            <a:avLst/>
          </a:prstGeom>
          <a:solidFill>
            <a:srgbClr val="ffffff"/>
          </a:solidFill>
          <a:ln w="25560">
            <a:solidFill>
              <a:srgbClr val="bcbcb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0000"/>
              </a:lnSpc>
              <a:spcAft>
                <a:spcPts val="788"/>
              </a:spcAft>
              <a:tabLst>
                <a:tab algn="l" pos="0"/>
                <a:tab algn="l" pos="1111320"/>
                <a:tab algn="l" pos="2222640"/>
                <a:tab algn="l" pos="3333600"/>
                <a:tab algn="l" pos="4444920"/>
                <a:tab algn="l" pos="5556240"/>
                <a:tab algn="l" pos="6667560"/>
                <a:tab algn="l" pos="7778880"/>
                <a:tab algn="l" pos="8889840"/>
                <a:tab algn="l" pos="100011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ssessed for eligibility (n=97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矩形 9"/>
          <p:cNvSpPr/>
          <p:nvPr/>
        </p:nvSpPr>
        <p:spPr>
          <a:xfrm>
            <a:off x="260280" y="8459640"/>
            <a:ext cx="5472360" cy="555840"/>
          </a:xfrm>
          <a:prstGeom prst="rect">
            <a:avLst/>
          </a:prstGeom>
          <a:solidFill>
            <a:srgbClr val="ffffff"/>
          </a:solidFill>
          <a:ln w="25560">
            <a:solidFill>
              <a:srgbClr val="bcbcb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0000"/>
              </a:lnSpc>
              <a:spcAft>
                <a:spcPts val="788"/>
              </a:spcAft>
              <a:tabLst>
                <a:tab algn="l" pos="0"/>
                <a:tab algn="l" pos="1111320"/>
                <a:tab algn="l" pos="2222640"/>
                <a:tab algn="l" pos="3333600"/>
                <a:tab algn="l" pos="4444920"/>
                <a:tab algn="l" pos="5556240"/>
                <a:tab algn="l" pos="6667560"/>
                <a:tab algn="l" pos="7778880"/>
                <a:tab algn="l" pos="8889840"/>
                <a:tab algn="l" pos="100011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nal analysi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矩形 11"/>
          <p:cNvSpPr/>
          <p:nvPr/>
        </p:nvSpPr>
        <p:spPr>
          <a:xfrm>
            <a:off x="271440" y="4788000"/>
            <a:ext cx="5472000" cy="560160"/>
          </a:xfrm>
          <a:prstGeom prst="rect">
            <a:avLst/>
          </a:prstGeom>
          <a:solidFill>
            <a:srgbClr val="ffffff"/>
          </a:solidFill>
          <a:ln w="25560">
            <a:solidFill>
              <a:srgbClr val="bcbcb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0000"/>
              </a:lnSpc>
              <a:spcAft>
                <a:spcPts val="788"/>
              </a:spcAft>
              <a:tabLst>
                <a:tab algn="l" pos="0"/>
                <a:tab algn="l" pos="1111320"/>
                <a:tab algn="l" pos="2222640"/>
                <a:tab algn="l" pos="3333600"/>
                <a:tab algn="l" pos="4444920"/>
                <a:tab algn="l" pos="5556240"/>
                <a:tab algn="l" pos="6667560"/>
                <a:tab algn="l" pos="7778880"/>
                <a:tab algn="l" pos="8889840"/>
                <a:tab algn="l" pos="100011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Education, anthropometric measurements, sample collection at baseline (n=7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矩形 12"/>
          <p:cNvSpPr/>
          <p:nvPr/>
        </p:nvSpPr>
        <p:spPr>
          <a:xfrm>
            <a:off x="271440" y="3924360"/>
            <a:ext cx="2005200" cy="468360"/>
          </a:xfrm>
          <a:prstGeom prst="rect">
            <a:avLst/>
          </a:prstGeom>
          <a:solidFill>
            <a:srgbClr val="ffffff"/>
          </a:solidFill>
          <a:ln w="25560">
            <a:solidFill>
              <a:srgbClr val="bcbcb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0000"/>
              </a:lnSpc>
              <a:spcAft>
                <a:spcPts val="788"/>
              </a:spcAft>
              <a:tabLst>
                <a:tab algn="l" pos="0"/>
                <a:tab algn="l" pos="1111320"/>
                <a:tab algn="l" pos="2222640"/>
                <a:tab algn="l" pos="3333600"/>
                <a:tab algn="l" pos="4444920"/>
                <a:tab algn="l" pos="5556240"/>
                <a:tab algn="l" pos="6667560"/>
                <a:tab algn="l" pos="7778880"/>
                <a:tab algn="l" pos="8889840"/>
                <a:tab algn="l" pos="100011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ASH (n=37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矩形 13"/>
          <p:cNvSpPr/>
          <p:nvPr/>
        </p:nvSpPr>
        <p:spPr>
          <a:xfrm>
            <a:off x="1630440" y="3147840"/>
            <a:ext cx="2733480" cy="416160"/>
          </a:xfrm>
          <a:prstGeom prst="rect">
            <a:avLst/>
          </a:prstGeom>
          <a:solidFill>
            <a:srgbClr val="ffffff"/>
          </a:solidFill>
          <a:ln w="25560">
            <a:solidFill>
              <a:srgbClr val="bcbcb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0000"/>
              </a:lnSpc>
              <a:spcAft>
                <a:spcPts val="788"/>
              </a:spcAft>
              <a:tabLst>
                <a:tab algn="l" pos="0"/>
                <a:tab algn="l" pos="1111320"/>
                <a:tab algn="l" pos="2222640"/>
                <a:tab algn="l" pos="3333600"/>
                <a:tab algn="l" pos="4444920"/>
                <a:tab algn="l" pos="5556240"/>
                <a:tab algn="l" pos="6667560"/>
                <a:tab algn="l" pos="7778880"/>
                <a:tab algn="l" pos="8889840"/>
                <a:tab algn="l" pos="100011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andomized (n=7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矩形 14"/>
          <p:cNvSpPr/>
          <p:nvPr/>
        </p:nvSpPr>
        <p:spPr>
          <a:xfrm>
            <a:off x="3284640" y="3927600"/>
            <a:ext cx="2458800" cy="465120"/>
          </a:xfrm>
          <a:prstGeom prst="rect">
            <a:avLst/>
          </a:prstGeom>
          <a:solidFill>
            <a:srgbClr val="ffffff"/>
          </a:solidFill>
          <a:ln w="25560">
            <a:solidFill>
              <a:srgbClr val="bcbcb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0000"/>
              </a:lnSpc>
              <a:spcAft>
                <a:spcPts val="788"/>
              </a:spcAft>
              <a:tabLst>
                <a:tab algn="l" pos="0"/>
                <a:tab algn="l" pos="1111320"/>
                <a:tab algn="l" pos="2222640"/>
                <a:tab algn="l" pos="3333600"/>
                <a:tab algn="l" pos="4444920"/>
                <a:tab algn="l" pos="5556240"/>
                <a:tab algn="l" pos="6667560"/>
                <a:tab algn="l" pos="7778880"/>
                <a:tab algn="l" pos="8889840"/>
                <a:tab algn="l" pos="100011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ASH+TRE (n=37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矩形 15"/>
          <p:cNvSpPr/>
          <p:nvPr/>
        </p:nvSpPr>
        <p:spPr>
          <a:xfrm>
            <a:off x="271440" y="5740560"/>
            <a:ext cx="5472000" cy="560160"/>
          </a:xfrm>
          <a:prstGeom prst="rect">
            <a:avLst/>
          </a:prstGeom>
          <a:solidFill>
            <a:srgbClr val="ffffff"/>
          </a:solidFill>
          <a:ln w="25560">
            <a:solidFill>
              <a:srgbClr val="bcbcb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0000"/>
              </a:lnSpc>
              <a:spcAft>
                <a:spcPts val="788"/>
              </a:spcAft>
              <a:tabLst>
                <a:tab algn="l" pos="0"/>
                <a:tab algn="l" pos="1111320"/>
                <a:tab algn="l" pos="2222640"/>
                <a:tab algn="l" pos="3333600"/>
                <a:tab algn="l" pos="4444920"/>
                <a:tab algn="l" pos="5556240"/>
                <a:tab algn="l" pos="6667560"/>
                <a:tab algn="l" pos="7778880"/>
                <a:tab algn="l" pos="8889840"/>
                <a:tab algn="l" pos="100011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lood pressure monitoring, Diet tracking, Daily communication (n=7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2" name="直接箭头连接符 2"/>
          <p:cNvCxnSpPr/>
          <p:nvPr/>
        </p:nvCxnSpPr>
        <p:spPr>
          <a:xfrm>
            <a:off x="2707920" y="858600"/>
            <a:ext cx="1080" cy="361080"/>
          </a:xfrm>
          <a:prstGeom prst="straightConnector1">
            <a:avLst/>
          </a:prstGeom>
          <a:ln w="19080">
            <a:solidFill>
              <a:srgbClr val="000000"/>
            </a:solidFill>
            <a:round/>
            <a:tailEnd len="med" type="arrow" w="med"/>
          </a:ln>
        </p:spPr>
      </p:cxnSp>
      <p:cxnSp>
        <p:nvCxnSpPr>
          <p:cNvPr id="93" name="直接箭头连接符 18"/>
          <p:cNvCxnSpPr/>
          <p:nvPr/>
        </p:nvCxnSpPr>
        <p:spPr>
          <a:xfrm>
            <a:off x="3644640" y="3563640"/>
            <a:ext cx="1080" cy="361080"/>
          </a:xfrm>
          <a:prstGeom prst="straightConnector1">
            <a:avLst/>
          </a:prstGeom>
          <a:ln w="19080">
            <a:solidFill>
              <a:srgbClr val="000000"/>
            </a:solidFill>
            <a:round/>
            <a:tailEnd len="med" type="arrow" w="med"/>
          </a:ln>
        </p:spPr>
      </p:cxnSp>
      <p:cxnSp>
        <p:nvCxnSpPr>
          <p:cNvPr id="94" name="直接箭头连接符 19"/>
          <p:cNvCxnSpPr/>
          <p:nvPr/>
        </p:nvCxnSpPr>
        <p:spPr>
          <a:xfrm>
            <a:off x="1773000" y="3563640"/>
            <a:ext cx="1080" cy="361080"/>
          </a:xfrm>
          <a:prstGeom prst="straightConnector1">
            <a:avLst/>
          </a:prstGeom>
          <a:ln w="19080">
            <a:solidFill>
              <a:srgbClr val="000000"/>
            </a:solidFill>
            <a:round/>
            <a:tailEnd len="med" type="arrow" w="med"/>
          </a:ln>
        </p:spPr>
      </p:cxnSp>
      <p:cxnSp>
        <p:nvCxnSpPr>
          <p:cNvPr id="95" name="直接箭头连接符 20"/>
          <p:cNvCxnSpPr/>
          <p:nvPr/>
        </p:nvCxnSpPr>
        <p:spPr>
          <a:xfrm>
            <a:off x="2707920" y="1692000"/>
            <a:ext cx="1080" cy="1456200"/>
          </a:xfrm>
          <a:prstGeom prst="straightConnector1">
            <a:avLst/>
          </a:prstGeom>
          <a:ln w="19080">
            <a:solidFill>
              <a:srgbClr val="000000"/>
            </a:solidFill>
            <a:round/>
            <a:tailEnd len="med" type="arrow" w="med"/>
          </a:ln>
        </p:spPr>
      </p:cxnSp>
      <p:cxnSp>
        <p:nvCxnSpPr>
          <p:cNvPr id="96" name="直接箭头连接符 22"/>
          <p:cNvCxnSpPr/>
          <p:nvPr/>
        </p:nvCxnSpPr>
        <p:spPr>
          <a:xfrm>
            <a:off x="1766520" y="4427280"/>
            <a:ext cx="1080" cy="361080"/>
          </a:xfrm>
          <a:prstGeom prst="straightConnector1">
            <a:avLst/>
          </a:prstGeom>
          <a:ln w="19080">
            <a:solidFill>
              <a:srgbClr val="000000"/>
            </a:solidFill>
            <a:round/>
            <a:tailEnd len="med" type="arrow" w="med"/>
          </a:ln>
        </p:spPr>
      </p:cxnSp>
      <p:cxnSp>
        <p:nvCxnSpPr>
          <p:cNvPr id="97" name="直接箭头连接符 23"/>
          <p:cNvCxnSpPr/>
          <p:nvPr/>
        </p:nvCxnSpPr>
        <p:spPr>
          <a:xfrm>
            <a:off x="2707920" y="8067240"/>
            <a:ext cx="1080" cy="359640"/>
          </a:xfrm>
          <a:prstGeom prst="straightConnector1">
            <a:avLst/>
          </a:prstGeom>
          <a:ln w="19080">
            <a:solidFill>
              <a:srgbClr val="000000"/>
            </a:solidFill>
            <a:round/>
            <a:tailEnd len="med" type="arrow" w="med"/>
          </a:ln>
        </p:spPr>
      </p:cxnSp>
      <p:cxnSp>
        <p:nvCxnSpPr>
          <p:cNvPr id="98" name="直接箭头连接符 26"/>
          <p:cNvCxnSpPr/>
          <p:nvPr/>
        </p:nvCxnSpPr>
        <p:spPr>
          <a:xfrm>
            <a:off x="2707920" y="6300720"/>
            <a:ext cx="1080" cy="721440"/>
          </a:xfrm>
          <a:prstGeom prst="straightConnector1">
            <a:avLst/>
          </a:prstGeom>
          <a:ln w="19080">
            <a:solidFill>
              <a:srgbClr val="000000"/>
            </a:solidFill>
            <a:round/>
            <a:tailEnd len="med" type="arrow" w="med"/>
          </a:ln>
        </p:spPr>
      </p:cxnSp>
      <p:cxnSp>
        <p:nvCxnSpPr>
          <p:cNvPr id="99" name="直接箭头连接符 27"/>
          <p:cNvCxnSpPr/>
          <p:nvPr/>
        </p:nvCxnSpPr>
        <p:spPr>
          <a:xfrm>
            <a:off x="2707920" y="5363640"/>
            <a:ext cx="1080" cy="361080"/>
          </a:xfrm>
          <a:prstGeom prst="straightConnector1">
            <a:avLst/>
          </a:prstGeom>
          <a:ln w="19080">
            <a:solidFill>
              <a:srgbClr val="000000"/>
            </a:solidFill>
            <a:round/>
            <a:tailEnd len="med" type="arrow" w="med"/>
          </a:ln>
        </p:spPr>
      </p:cxnSp>
      <p:cxnSp>
        <p:nvCxnSpPr>
          <p:cNvPr id="100" name="直接箭头连接符 28"/>
          <p:cNvCxnSpPr/>
          <p:nvPr/>
        </p:nvCxnSpPr>
        <p:spPr>
          <a:xfrm>
            <a:off x="3644640" y="4427280"/>
            <a:ext cx="1080" cy="361080"/>
          </a:xfrm>
          <a:prstGeom prst="straightConnector1">
            <a:avLst/>
          </a:prstGeom>
          <a:ln w="19080">
            <a:solidFill>
              <a:srgbClr val="000000"/>
            </a:solidFill>
            <a:round/>
            <a:tailEnd len="med" type="arrow" w="med"/>
          </a:ln>
        </p:spPr>
      </p:cxnSp>
      <p:sp>
        <p:nvSpPr>
          <p:cNvPr id="101" name="矩形 21"/>
          <p:cNvSpPr/>
          <p:nvPr/>
        </p:nvSpPr>
        <p:spPr>
          <a:xfrm>
            <a:off x="2852640" y="6408720"/>
            <a:ext cx="1352520" cy="465120"/>
          </a:xfrm>
          <a:prstGeom prst="rect">
            <a:avLst/>
          </a:prstGeom>
          <a:solidFill>
            <a:srgbClr val="ffffff"/>
          </a:solidFill>
          <a:ln w="25560">
            <a:solidFill>
              <a:srgbClr val="bcbcb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0000"/>
              </a:lnSpc>
              <a:spcAft>
                <a:spcPts val="788"/>
              </a:spcAft>
              <a:tabLst>
                <a:tab algn="l" pos="0"/>
                <a:tab algn="l" pos="1111320"/>
                <a:tab algn="l" pos="2222640"/>
                <a:tab algn="l" pos="3333600"/>
                <a:tab algn="l" pos="4444920"/>
                <a:tab algn="l" pos="5556240"/>
                <a:tab algn="l" pos="6667560"/>
                <a:tab algn="l" pos="7778880"/>
                <a:tab algn="l" pos="8889840"/>
                <a:tab algn="l" pos="100011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6 week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2" name="TextBox 14" descr=""/>
          <p:cNvPicPr/>
          <p:nvPr/>
        </p:nvPicPr>
        <p:blipFill>
          <a:blip r:embed="rId1"/>
          <a:stretch/>
        </p:blipFill>
        <p:spPr>
          <a:xfrm>
            <a:off x="-36360" y="-27000"/>
            <a:ext cx="5256000" cy="370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" name="图片 1" descr=""/>
          <p:cNvPicPr/>
          <p:nvPr/>
        </p:nvPicPr>
        <p:blipFill>
          <a:blip r:embed="rId1"/>
          <a:stretch/>
        </p:blipFill>
        <p:spPr>
          <a:xfrm>
            <a:off x="3268800" y="2708280"/>
            <a:ext cx="3473280" cy="2712960"/>
          </a:xfrm>
          <a:prstGeom prst="rect">
            <a:avLst/>
          </a:prstGeom>
          <a:ln w="0">
            <a:noFill/>
          </a:ln>
        </p:spPr>
      </p:pic>
      <p:pic>
        <p:nvPicPr>
          <p:cNvPr id="104" name="图片 3" descr=""/>
          <p:cNvPicPr/>
          <p:nvPr/>
        </p:nvPicPr>
        <p:blipFill>
          <a:blip r:embed="rId2"/>
          <a:stretch/>
        </p:blipFill>
        <p:spPr>
          <a:xfrm>
            <a:off x="-100080" y="2662200"/>
            <a:ext cx="3529080" cy="2768760"/>
          </a:xfrm>
          <a:prstGeom prst="rect">
            <a:avLst/>
          </a:prstGeom>
          <a:ln w="0">
            <a:noFill/>
          </a:ln>
        </p:spPr>
      </p:pic>
      <p:sp>
        <p:nvSpPr>
          <p:cNvPr id="105" name="TextBox 1"/>
          <p:cNvSpPr/>
          <p:nvPr/>
        </p:nvSpPr>
        <p:spPr>
          <a:xfrm>
            <a:off x="0" y="6480"/>
            <a:ext cx="394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2"/>
          <p:cNvSpPr/>
          <p:nvPr/>
        </p:nvSpPr>
        <p:spPr>
          <a:xfrm>
            <a:off x="3340080" y="2332080"/>
            <a:ext cx="59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9"/>
          <p:cNvSpPr/>
          <p:nvPr/>
        </p:nvSpPr>
        <p:spPr>
          <a:xfrm>
            <a:off x="44280" y="2340000"/>
            <a:ext cx="59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TextBox 14"/>
          <p:cNvSpPr/>
          <p:nvPr/>
        </p:nvSpPr>
        <p:spPr>
          <a:xfrm>
            <a:off x="27000" y="58680"/>
            <a:ext cx="394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 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15"/>
          <p:cNvSpPr/>
          <p:nvPr/>
        </p:nvSpPr>
        <p:spPr>
          <a:xfrm>
            <a:off x="252360" y="4932360"/>
            <a:ext cx="59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16"/>
          <p:cNvSpPr/>
          <p:nvPr/>
        </p:nvSpPr>
        <p:spPr>
          <a:xfrm>
            <a:off x="243000" y="611280"/>
            <a:ext cx="59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1" name="图片 1" descr=""/>
          <p:cNvPicPr/>
          <p:nvPr/>
        </p:nvPicPr>
        <p:blipFill>
          <a:blip r:embed="rId1"/>
          <a:stretch/>
        </p:blipFill>
        <p:spPr>
          <a:xfrm>
            <a:off x="789120" y="5076720"/>
            <a:ext cx="4655880" cy="4000680"/>
          </a:xfrm>
          <a:prstGeom prst="rect">
            <a:avLst/>
          </a:prstGeom>
          <a:ln w="0">
            <a:noFill/>
          </a:ln>
        </p:spPr>
      </p:pic>
      <p:pic>
        <p:nvPicPr>
          <p:cNvPr id="112" name="图片 2" descr=""/>
          <p:cNvPicPr/>
          <p:nvPr/>
        </p:nvPicPr>
        <p:blipFill>
          <a:blip r:embed="rId2"/>
          <a:stretch/>
        </p:blipFill>
        <p:spPr>
          <a:xfrm>
            <a:off x="781200" y="770040"/>
            <a:ext cx="4519440" cy="4119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3" name="图片 4" descr=""/>
          <p:cNvPicPr/>
          <p:nvPr/>
        </p:nvPicPr>
        <p:blipFill>
          <a:blip r:embed="rId1"/>
          <a:stretch/>
        </p:blipFill>
        <p:spPr>
          <a:xfrm>
            <a:off x="1311120" y="1852560"/>
            <a:ext cx="3595680" cy="2319480"/>
          </a:xfrm>
          <a:prstGeom prst="rect">
            <a:avLst/>
          </a:prstGeom>
          <a:ln w="0">
            <a:noFill/>
          </a:ln>
        </p:spPr>
      </p:pic>
      <p:pic>
        <p:nvPicPr>
          <p:cNvPr id="114" name="图片 6" descr=""/>
          <p:cNvPicPr/>
          <p:nvPr/>
        </p:nvPicPr>
        <p:blipFill>
          <a:blip r:embed="rId2"/>
          <a:stretch/>
        </p:blipFill>
        <p:spPr>
          <a:xfrm>
            <a:off x="1401840" y="4987800"/>
            <a:ext cx="3504960" cy="2113200"/>
          </a:xfrm>
          <a:prstGeom prst="rect">
            <a:avLst/>
          </a:prstGeom>
          <a:ln w="0">
            <a:noFill/>
          </a:ln>
        </p:spPr>
      </p:pic>
      <p:sp>
        <p:nvSpPr>
          <p:cNvPr id="115" name="TextBox 1"/>
          <p:cNvSpPr/>
          <p:nvPr/>
        </p:nvSpPr>
        <p:spPr>
          <a:xfrm>
            <a:off x="0" y="6480"/>
            <a:ext cx="394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2"/>
          <p:cNvSpPr/>
          <p:nvPr/>
        </p:nvSpPr>
        <p:spPr>
          <a:xfrm>
            <a:off x="1216080" y="4732200"/>
            <a:ext cx="59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9"/>
          <p:cNvSpPr/>
          <p:nvPr/>
        </p:nvSpPr>
        <p:spPr>
          <a:xfrm>
            <a:off x="1116000" y="1560600"/>
            <a:ext cx="59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02T08:56:59Z</dcterms:created>
  <dc:creator>dongdong zhou</dc:creator>
  <dc:description/>
  <dc:language>en-US</dc:language>
  <cp:lastModifiedBy>Better </cp:lastModifiedBy>
  <dcterms:modified xsi:type="dcterms:W3CDTF">2024-04-15T04:38:25Z</dcterms:modified>
  <cp:revision>29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140F20150F848C681B2F9CC279D4F5A_12</vt:lpwstr>
  </property>
  <property fmtid="{D5CDD505-2E9C-101B-9397-08002B2CF9AE}" pid="3" name="KSOProductBuildVer">
    <vt:lpwstr>2052-12.1.0.16729</vt:lpwstr>
  </property>
</Properties>
</file>